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858000" cy="9144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-360" y="0"/>
            <a:ext cx="2971800" cy="458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84400" y="0"/>
            <a:ext cx="2971800" cy="458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ja-JP" sz="1200" spc="-1" strike="noStrike">
                <a:solidFill>
                  <a:srgbClr val="000000"/>
                </a:solidFill>
                <a:latin typeface="游ゴシック"/>
                <a:ea typeface="游ゴシック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ja-JP" sz="1200" spc="-1" strike="noStrike">
                <a:solidFill>
                  <a:srgbClr val="000000"/>
                </a:solidFill>
                <a:latin typeface="游ゴシック"/>
                <a:ea typeface="游ゴシック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1371600" y="1142640"/>
            <a:ext cx="4114800" cy="308628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 Light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85800" y="4400280"/>
            <a:ext cx="5486400" cy="36003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游ゴシック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游ゴシック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-360" y="8685360"/>
            <a:ext cx="2971800" cy="458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84400" y="8685360"/>
            <a:ext cx="2971800" cy="458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ja-JP" sz="1200" spc="-1" strike="noStrike">
                <a:solidFill>
                  <a:srgbClr val="000000"/>
                </a:solidFill>
                <a:latin typeface="游ゴシック"/>
                <a:ea typeface="游ゴシック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E8E2ED8C-66AF-4AD3-98EC-58E261024666}" type="slidenum">
              <a:rPr b="0" lang="ja-JP" sz="1200" spc="-1" strike="noStrike">
                <a:solidFill>
                  <a:srgbClr val="000000"/>
                </a:solidFill>
                <a:latin typeface="游ゴシック"/>
                <a:ea typeface="游ゴシック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4" name="PlaceHolder 1"/>
          <p:cNvSpPr>
            <a:spLocks noGrp="1"/>
          </p:cNvSpPr>
          <p:nvPr>
            <p:ph type="sldImg"/>
          </p:nvPr>
        </p:nvSpPr>
        <p:spPr>
          <a:xfrm>
            <a:off x="1168560" y="1243080"/>
            <a:ext cx="4470120" cy="3352680"/>
          </a:xfrm>
          <a:prstGeom prst="rect">
            <a:avLst/>
          </a:prstGeom>
          <a:ln w="0">
            <a:noFill/>
          </a:ln>
        </p:spPr>
      </p:sp>
      <p:sp>
        <p:nvSpPr>
          <p:cNvPr id="75" name="PlaceHolder 2"/>
          <p:cNvSpPr>
            <a:spLocks noGrp="1"/>
          </p:cNvSpPr>
          <p:nvPr>
            <p:ph type="body"/>
          </p:nvPr>
        </p:nvSpPr>
        <p:spPr>
          <a:xfrm>
            <a:off x="685800" y="4400280"/>
            <a:ext cx="5486400" cy="36003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游ゴシック"/>
              <a:ea typeface="游ゴシック"/>
            </a:endParaRPr>
          </a:p>
        </p:txBody>
      </p:sp>
      <p:sp>
        <p:nvSpPr>
          <p:cNvPr id="76" name="スライド番号プレースホルダー 3"/>
          <p:cNvSpPr/>
          <p:nvPr/>
        </p:nvSpPr>
        <p:spPr>
          <a:xfrm>
            <a:off x="3884760" y="8685360"/>
            <a:ext cx="2971800" cy="458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CC3A7695-CDAD-4FAE-B60D-37A1AF2D78C9}" type="slidenum">
              <a:rPr b="0" lang="ja-JP" sz="1200" spc="-1" strike="noStrike">
                <a:solidFill>
                  <a:srgbClr val="000000"/>
                </a:solidFill>
                <a:latin typeface="游ゴシック"/>
                <a:ea typeface="游ゴシック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6255A9A-197A-4497-8250-AF7485706CAF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628560" y="1825200"/>
            <a:ext cx="788688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628560" y="4098240"/>
            <a:ext cx="788688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FFB4C67-6BA4-4931-A731-6C02355A42A6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628560" y="182520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0280" y="182520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628560" y="409824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0280" y="409824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BBD8447-8282-454E-83A1-EE0F4C38E6FF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628560" y="1825200"/>
            <a:ext cx="2539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95440" y="1825200"/>
            <a:ext cx="2539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5962320" y="1825200"/>
            <a:ext cx="2539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628560" y="4098240"/>
            <a:ext cx="2539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95440" y="4098240"/>
            <a:ext cx="2539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5962320" y="4098240"/>
            <a:ext cx="2539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9415020-A89F-4FB3-A2BE-E6000967BA71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628560" y="1825200"/>
            <a:ext cx="7886880" cy="43513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0000"/>
              </a:lnSpc>
              <a:spcBef>
                <a:spcPts val="10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88D8A91-3290-458D-9B14-CAC1DD4B1EF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628560" y="1825200"/>
            <a:ext cx="788688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865EDE0-E8A3-4C60-A0A6-6A5CD33A1E3E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628560" y="1825200"/>
            <a:ext cx="384876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0280" y="1825200"/>
            <a:ext cx="384876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B9CB0EC-F224-4A06-953D-77D7D9F735F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DCA143D-49BF-4B4E-9B8E-113B433E674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628560" y="365040"/>
            <a:ext cx="7886880" cy="6145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lnSpc>
                <a:spcPct val="90000"/>
              </a:lnSpc>
              <a:spcBef>
                <a:spcPts val="1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D212468-78EC-4AD5-97D7-8486CCF8B3A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628560" y="182520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0280" y="1825200"/>
            <a:ext cx="384876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628560" y="409824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4134AE4-2BC8-4EDE-972D-2D4D416F233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628560" y="1825200"/>
            <a:ext cx="384876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0280" y="182520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0280" y="409824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AC65CEF-088E-4F74-A5E5-E1F7D7620E8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628560" y="182520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0280" y="182520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628560" y="4098240"/>
            <a:ext cx="788688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1527EDE-100D-411E-802A-B9C1FBF56AE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 Light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628560" y="1825200"/>
            <a:ext cx="788688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2286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1" marL="6858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628200" y="6356520"/>
            <a:ext cx="205740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ja-JP" sz="1200" spc="-1" strike="noStrike">
                <a:solidFill>
                  <a:srgbClr val="898989"/>
                </a:solidFill>
                <a:latin typeface="Calibri"/>
                <a:ea typeface="游ゴシック"/>
              </a:defRPr>
            </a:lvl1pPr>
          </a:lstStyle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ja-JP" sz="1200" spc="-1" strike="noStrike">
                <a:solidFill>
                  <a:srgbClr val="898989"/>
                </a:solidFill>
                <a:latin typeface="Calibri"/>
                <a:ea typeface="游ゴシック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029040" y="6356520"/>
            <a:ext cx="30859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457680" y="6356520"/>
            <a:ext cx="205740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ja-JP" sz="1200" spc="-1" strike="noStrike">
                <a:solidFill>
                  <a:srgbClr val="898989"/>
                </a:solidFill>
                <a:latin typeface="Calibri"/>
                <a:ea typeface="游ゴシック"/>
              </a:defRPr>
            </a:lvl1pPr>
          </a:lstStyle>
          <a:p>
            <a: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E33284A4-A0DF-4FCA-8B05-B9D4E8B26745}" type="slidenum">
              <a:rPr b="0" lang="ja-JP" sz="1200" spc="-1" strike="noStrike">
                <a:solidFill>
                  <a:srgbClr val="898989"/>
                </a:solidFill>
                <a:latin typeface="Calibri"/>
                <a:ea typeface="游ゴシック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8" name="グループ化 1"/>
          <p:cNvGrpSpPr/>
          <p:nvPr/>
        </p:nvGrpSpPr>
        <p:grpSpPr>
          <a:xfrm>
            <a:off x="257040" y="358920"/>
            <a:ext cx="8782200" cy="5638680"/>
            <a:chOff x="257040" y="358920"/>
            <a:chExt cx="8782200" cy="5638680"/>
          </a:xfrm>
        </p:grpSpPr>
        <p:grpSp>
          <p:nvGrpSpPr>
            <p:cNvPr id="49" name="グループ化 9"/>
            <p:cNvGrpSpPr/>
            <p:nvPr/>
          </p:nvGrpSpPr>
          <p:grpSpPr>
            <a:xfrm>
              <a:off x="257040" y="358920"/>
              <a:ext cx="4251240" cy="5638680"/>
              <a:chOff x="257040" y="358920"/>
              <a:chExt cx="4251240" cy="5638680"/>
            </a:xfrm>
          </p:grpSpPr>
          <p:grpSp>
            <p:nvGrpSpPr>
              <p:cNvPr id="50" name="グループ化 14"/>
              <p:cNvGrpSpPr/>
              <p:nvPr/>
            </p:nvGrpSpPr>
            <p:grpSpPr>
              <a:xfrm>
                <a:off x="257040" y="735480"/>
                <a:ext cx="4199400" cy="5262120"/>
                <a:chOff x="257040" y="735480"/>
                <a:chExt cx="4199400" cy="5262120"/>
              </a:xfrm>
            </p:grpSpPr>
            <p:cxnSp>
              <p:nvCxnSpPr>
                <p:cNvPr id="51" name="直線矢印コネクタ 23"/>
                <p:cNvCxnSpPr/>
                <p:nvPr/>
              </p:nvCxnSpPr>
              <p:spPr>
                <a:xfrm flipH="1">
                  <a:off x="347040" y="1335240"/>
                  <a:ext cx="24480" cy="4016880"/>
                </a:xfrm>
                <a:prstGeom prst="straightConnector1">
                  <a:avLst/>
                </a:prstGeom>
                <a:ln w="19080">
                  <a:solidFill>
                    <a:srgbClr val="000000"/>
                  </a:solidFill>
                  <a:miter/>
                  <a:tailEnd len="med" type="triangle" w="med"/>
                </a:ln>
              </p:spPr>
            </p:cxnSp>
            <p:cxnSp>
              <p:nvCxnSpPr>
                <p:cNvPr id="52" name="直線矢印コネクタ 24"/>
                <p:cNvCxnSpPr/>
                <p:nvPr/>
              </p:nvCxnSpPr>
              <p:spPr>
                <a:xfrm>
                  <a:off x="371160" y="2597040"/>
                  <a:ext cx="491040" cy="1080"/>
                </a:xfrm>
                <a:prstGeom prst="straightConnector1">
                  <a:avLst/>
                </a:prstGeom>
                <a:ln w="19080">
                  <a:solidFill>
                    <a:srgbClr val="000000"/>
                  </a:solidFill>
                  <a:miter/>
                  <a:tailEnd len="med" type="triangle" w="med"/>
                </a:ln>
              </p:spPr>
            </p:cxnSp>
            <p:sp>
              <p:nvSpPr>
                <p:cNvPr id="53" name="テキスト ボックス 25"/>
                <p:cNvSpPr/>
                <p:nvPr/>
              </p:nvSpPr>
              <p:spPr>
                <a:xfrm>
                  <a:off x="869760" y="1633680"/>
                  <a:ext cx="3575520" cy="2071800"/>
                </a:xfrm>
                <a:prstGeom prst="rect">
                  <a:avLst/>
                </a:prstGeom>
                <a:solidFill>
                  <a:srgbClr val="ffffff"/>
                </a:solidFill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 marL="114480" indent="-114480">
                    <a:lnSpc>
                      <a:spcPct val="100000"/>
                    </a:lnSpc>
                    <a:tabLst>
                      <a:tab algn="l" pos="0"/>
                      <a:tab algn="l" pos="912960"/>
                      <a:tab algn="l" pos="1825560"/>
                      <a:tab algn="l" pos="2738520"/>
                      <a:tab algn="l" pos="3651120"/>
                      <a:tab algn="l" pos="4564080"/>
                      <a:tab algn="l" pos="5477040"/>
                      <a:tab algn="l" pos="6389640"/>
                      <a:tab algn="l" pos="7302600"/>
                      <a:tab algn="l" pos="8215200"/>
                      <a:tab algn="l" pos="9128160"/>
                      <a:tab algn="l" pos="10040760"/>
                      <a:tab algn="l" pos="10953720"/>
                    </a:tabLst>
                  </a:pPr>
                  <a:r>
                    <a:rPr b="0" lang="en-US" sz="1800" spc="-1" strike="noStrike">
                      <a:solidFill>
                        <a:srgbClr val="000000"/>
                      </a:solidFill>
                      <a:latin typeface="Arial"/>
                      <a:ea typeface="游ゴシック"/>
                    </a:rPr>
                    <a:t>Excluded (n=17)</a:t>
                  </a: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  <a:p>
                  <a:pPr marL="114480" indent="-114480">
                    <a:lnSpc>
                      <a:spcPct val="100000"/>
                    </a:lnSpc>
                    <a:tabLst>
                      <a:tab algn="l" pos="0"/>
                      <a:tab algn="l" pos="912960"/>
                      <a:tab algn="l" pos="1825560"/>
                      <a:tab algn="l" pos="2738520"/>
                      <a:tab algn="l" pos="3651120"/>
                      <a:tab algn="l" pos="4564080"/>
                      <a:tab algn="l" pos="5477040"/>
                      <a:tab algn="l" pos="6389640"/>
                      <a:tab algn="l" pos="7302600"/>
                      <a:tab algn="l" pos="8215200"/>
                      <a:tab algn="l" pos="9128160"/>
                      <a:tab algn="l" pos="10040760"/>
                      <a:tab algn="l" pos="10953720"/>
                    </a:tabLst>
                  </a:pPr>
                  <a:r>
                    <a:rPr b="0" lang="ja-JP" sz="1600" spc="-1" strike="noStrike">
                      <a:solidFill>
                        <a:srgbClr val="000000"/>
                      </a:solidFill>
                      <a:latin typeface="Arial"/>
                      <a:ea typeface="游ゴシック"/>
                    </a:rPr>
                    <a:t>・</a:t>
                  </a:r>
                  <a:r>
                    <a:rPr b="0" lang="en-US" sz="1600" spc="-1" strike="noStrike">
                      <a:solidFill>
                        <a:srgbClr val="000000"/>
                      </a:solidFill>
                      <a:latin typeface="Arial"/>
                      <a:ea typeface="游ゴシック"/>
                    </a:rPr>
                    <a:t>Other histological types</a:t>
                  </a:r>
                  <a:endParaRPr b="0" lang="en-US" sz="1600" spc="-1" strike="noStrike">
                    <a:solidFill>
                      <a:srgbClr val="000000"/>
                    </a:solidFill>
                    <a:latin typeface="Calibri"/>
                  </a:endParaRPr>
                </a:p>
                <a:p>
                  <a:pPr marL="114480" indent="-114480">
                    <a:lnSpc>
                      <a:spcPct val="100000"/>
                    </a:lnSpc>
                    <a:tabLst>
                      <a:tab algn="l" pos="0"/>
                      <a:tab algn="l" pos="912960"/>
                      <a:tab algn="l" pos="1825560"/>
                      <a:tab algn="l" pos="2738520"/>
                      <a:tab algn="l" pos="3651120"/>
                      <a:tab algn="l" pos="4564080"/>
                      <a:tab algn="l" pos="5477040"/>
                      <a:tab algn="l" pos="6389640"/>
                      <a:tab algn="l" pos="7302600"/>
                      <a:tab algn="l" pos="8215200"/>
                      <a:tab algn="l" pos="9128160"/>
                      <a:tab algn="l" pos="10040760"/>
                      <a:tab algn="l" pos="10953720"/>
                    </a:tabLst>
                  </a:pPr>
                  <a:r>
                    <a:rPr b="0" lang="ja-JP" sz="1600" spc="-1" strike="noStrike">
                      <a:solidFill>
                        <a:srgbClr val="000000"/>
                      </a:solidFill>
                      <a:latin typeface="Arial"/>
                      <a:ea typeface="游ゴシック"/>
                    </a:rPr>
                    <a:t>　</a:t>
                  </a:r>
                  <a:r>
                    <a:rPr b="0" lang="en-US" sz="1600" spc="-1" strike="noStrike">
                      <a:solidFill>
                        <a:srgbClr val="000000"/>
                      </a:solidFill>
                      <a:latin typeface="Arial"/>
                      <a:ea typeface="游ゴシック"/>
                    </a:rPr>
                    <a:t>Adenocarcinoma (n=5)</a:t>
                  </a:r>
                  <a:endParaRPr b="0" lang="en-US" sz="1600" spc="-1" strike="noStrike">
                    <a:solidFill>
                      <a:srgbClr val="000000"/>
                    </a:solidFill>
                    <a:latin typeface="Calibri"/>
                  </a:endParaRPr>
                </a:p>
                <a:p>
                  <a:pPr marL="114480" indent="-114480">
                    <a:lnSpc>
                      <a:spcPct val="100000"/>
                    </a:lnSpc>
                    <a:tabLst>
                      <a:tab algn="l" pos="0"/>
                      <a:tab algn="l" pos="912960"/>
                      <a:tab algn="l" pos="1825560"/>
                      <a:tab algn="l" pos="2738520"/>
                      <a:tab algn="l" pos="3651120"/>
                      <a:tab algn="l" pos="4564080"/>
                      <a:tab algn="l" pos="5477040"/>
                      <a:tab algn="l" pos="6389640"/>
                      <a:tab algn="l" pos="7302600"/>
                      <a:tab algn="l" pos="8215200"/>
                      <a:tab algn="l" pos="9128160"/>
                      <a:tab algn="l" pos="10040760"/>
                      <a:tab algn="l" pos="10953720"/>
                    </a:tabLst>
                  </a:pPr>
                  <a:r>
                    <a:rPr b="0" lang="ja-JP" sz="1600" spc="-1" strike="noStrike">
                      <a:solidFill>
                        <a:srgbClr val="000000"/>
                      </a:solidFill>
                      <a:latin typeface="Arial"/>
                      <a:ea typeface="游ゴシック"/>
                    </a:rPr>
                    <a:t>　</a:t>
                  </a:r>
                  <a:r>
                    <a:rPr b="0" lang="en-US" sz="1600" spc="-1" strike="noStrike">
                      <a:solidFill>
                        <a:srgbClr val="000000"/>
                      </a:solidFill>
                      <a:latin typeface="Arial"/>
                      <a:ea typeface="游ゴシック"/>
                    </a:rPr>
                    <a:t>Basal cell carcinoma (n=2)</a:t>
                  </a:r>
                  <a:endParaRPr b="0" lang="en-US" sz="1600" spc="-1" strike="noStrike">
                    <a:solidFill>
                      <a:srgbClr val="000000"/>
                    </a:solidFill>
                    <a:latin typeface="Calibri"/>
                  </a:endParaRPr>
                </a:p>
                <a:p>
                  <a:pPr marL="114480" indent="-114480">
                    <a:lnSpc>
                      <a:spcPct val="100000"/>
                    </a:lnSpc>
                    <a:tabLst>
                      <a:tab algn="l" pos="0"/>
                      <a:tab algn="l" pos="912960"/>
                      <a:tab algn="l" pos="1825560"/>
                      <a:tab algn="l" pos="2738520"/>
                      <a:tab algn="l" pos="3651120"/>
                      <a:tab algn="l" pos="4564080"/>
                      <a:tab algn="l" pos="5477040"/>
                      <a:tab algn="l" pos="6389640"/>
                      <a:tab algn="l" pos="7302600"/>
                      <a:tab algn="l" pos="8215200"/>
                      <a:tab algn="l" pos="9128160"/>
                      <a:tab algn="l" pos="10040760"/>
                      <a:tab algn="l" pos="10953720"/>
                    </a:tabLst>
                  </a:pPr>
                  <a:r>
                    <a:rPr b="0" lang="ja-JP" sz="1600" spc="-1" strike="noStrike">
                      <a:solidFill>
                        <a:srgbClr val="000000"/>
                      </a:solidFill>
                      <a:latin typeface="Arial"/>
                      <a:ea typeface="游ゴシック"/>
                    </a:rPr>
                    <a:t>　</a:t>
                  </a:r>
                  <a:r>
                    <a:rPr b="0" lang="en-US" sz="1600" spc="-1" strike="noStrike">
                      <a:solidFill>
                        <a:srgbClr val="000000"/>
                      </a:solidFill>
                      <a:latin typeface="Arial"/>
                      <a:ea typeface="游ゴシック"/>
                    </a:rPr>
                    <a:t>Paget’s disease (n=2)</a:t>
                  </a:r>
                  <a:endParaRPr b="0" lang="en-US" sz="1600" spc="-1" strike="noStrike">
                    <a:solidFill>
                      <a:srgbClr val="000000"/>
                    </a:solidFill>
                    <a:latin typeface="Calibri"/>
                  </a:endParaRPr>
                </a:p>
                <a:p>
                  <a:pPr marL="114480" indent="-114480">
                    <a:lnSpc>
                      <a:spcPct val="100000"/>
                    </a:lnSpc>
                    <a:tabLst>
                      <a:tab algn="l" pos="0"/>
                      <a:tab algn="l" pos="912960"/>
                      <a:tab algn="l" pos="1825560"/>
                      <a:tab algn="l" pos="2738520"/>
                      <a:tab algn="l" pos="3651120"/>
                      <a:tab algn="l" pos="4564080"/>
                      <a:tab algn="l" pos="5477040"/>
                      <a:tab algn="l" pos="6389640"/>
                      <a:tab algn="l" pos="7302600"/>
                      <a:tab algn="l" pos="8215200"/>
                      <a:tab algn="l" pos="9128160"/>
                      <a:tab algn="l" pos="10040760"/>
                      <a:tab algn="l" pos="10953720"/>
                    </a:tabLst>
                  </a:pPr>
                  <a:r>
                    <a:rPr b="0" lang="ja-JP" sz="1600" spc="-1" strike="noStrike">
                      <a:solidFill>
                        <a:srgbClr val="000000"/>
                      </a:solidFill>
                      <a:latin typeface="Arial"/>
                      <a:ea typeface="游ゴシック"/>
                    </a:rPr>
                    <a:t>　</a:t>
                  </a:r>
                  <a:r>
                    <a:rPr b="0" lang="en-US" sz="1600" spc="-1" strike="noStrike">
                      <a:solidFill>
                        <a:srgbClr val="000000"/>
                      </a:solidFill>
                      <a:latin typeface="Arial"/>
                      <a:ea typeface="游ゴシック"/>
                    </a:rPr>
                    <a:t>Miscellaneous (n=4)</a:t>
                  </a:r>
                  <a:endParaRPr b="0" lang="en-US" sz="1600" spc="-1" strike="noStrike">
                    <a:solidFill>
                      <a:srgbClr val="000000"/>
                    </a:solidFill>
                    <a:latin typeface="Calibri"/>
                  </a:endParaRPr>
                </a:p>
                <a:p>
                  <a:pPr marL="114480" indent="-114480">
                    <a:lnSpc>
                      <a:spcPct val="100000"/>
                    </a:lnSpc>
                    <a:tabLst>
                      <a:tab algn="l" pos="0"/>
                      <a:tab algn="l" pos="912960"/>
                      <a:tab algn="l" pos="1825560"/>
                      <a:tab algn="l" pos="2738520"/>
                      <a:tab algn="l" pos="3651120"/>
                      <a:tab algn="l" pos="4564080"/>
                      <a:tab algn="l" pos="5477040"/>
                      <a:tab algn="l" pos="6389640"/>
                      <a:tab algn="l" pos="7302600"/>
                      <a:tab algn="l" pos="8215200"/>
                      <a:tab algn="l" pos="9128160"/>
                      <a:tab algn="l" pos="10040760"/>
                      <a:tab algn="l" pos="10953720"/>
                    </a:tabLst>
                  </a:pPr>
                  <a:r>
                    <a:rPr b="0" lang="ja-JP" sz="1600" spc="-1" strike="noStrike">
                      <a:solidFill>
                        <a:srgbClr val="000000"/>
                      </a:solidFill>
                      <a:latin typeface="Arial"/>
                      <a:ea typeface="游ゴシック"/>
                    </a:rPr>
                    <a:t>・</a:t>
                  </a:r>
                  <a:r>
                    <a:rPr b="0" lang="en-US" sz="1600" spc="-1" strike="noStrike">
                      <a:solidFill>
                        <a:srgbClr val="000000"/>
                      </a:solidFill>
                      <a:latin typeface="Arial"/>
                      <a:ea typeface="游ゴシック"/>
                    </a:rPr>
                    <a:t> </a:t>
                  </a:r>
                  <a:r>
                    <a:rPr b="0" lang="en" sz="1600" spc="-1" strike="noStrike">
                      <a:solidFill>
                        <a:srgbClr val="000000"/>
                      </a:solidFill>
                      <a:latin typeface="Arial"/>
                      <a:ea typeface="游ゴシック"/>
                    </a:rPr>
                    <a:t>FFPE specimens not available (</a:t>
                  </a:r>
                  <a:r>
                    <a:rPr b="0" lang="en-US" sz="1600" spc="-1" strike="noStrike">
                      <a:solidFill>
                        <a:srgbClr val="000000"/>
                      </a:solidFill>
                      <a:latin typeface="Arial"/>
                      <a:ea typeface="游ゴシック"/>
                    </a:rPr>
                    <a:t>n=4</a:t>
                  </a:r>
                  <a:r>
                    <a:rPr b="0" lang="en" sz="1600" spc="-1" strike="noStrike">
                      <a:solidFill>
                        <a:srgbClr val="000000"/>
                      </a:solidFill>
                      <a:latin typeface="Arial"/>
                      <a:ea typeface="游ゴシック"/>
                    </a:rPr>
                    <a:t>)</a:t>
                  </a:r>
                  <a:endParaRPr b="0" lang="en-US" sz="16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54" name="テキスト ボックス 30"/>
                <p:cNvSpPr/>
                <p:nvPr/>
              </p:nvSpPr>
              <p:spPr>
                <a:xfrm>
                  <a:off x="272880" y="3846960"/>
                  <a:ext cx="4172760" cy="368280"/>
                </a:xfrm>
                <a:prstGeom prst="rect">
                  <a:avLst/>
                </a:prstGeom>
                <a:solidFill>
                  <a:srgbClr val="ffffff"/>
                </a:solidFill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2960"/>
                      <a:tab algn="l" pos="1825560"/>
                      <a:tab algn="l" pos="2738520"/>
                      <a:tab algn="l" pos="3651120"/>
                      <a:tab algn="l" pos="4564080"/>
                      <a:tab algn="l" pos="5477040"/>
                      <a:tab algn="l" pos="6389640"/>
                      <a:tab algn="l" pos="7302600"/>
                      <a:tab algn="l" pos="8215200"/>
                      <a:tab algn="l" pos="9128160"/>
                      <a:tab algn="l" pos="10040760"/>
                      <a:tab algn="l" pos="10953720"/>
                    </a:tabLst>
                  </a:pPr>
                  <a:r>
                    <a:rPr b="0" lang="en-US" sz="1800" spc="-1" strike="noStrike">
                      <a:solidFill>
                        <a:srgbClr val="000000"/>
                      </a:solidFill>
                      <a:latin typeface="Arial"/>
                      <a:ea typeface="游ゴシック"/>
                    </a:rPr>
                    <a:t>DNA extractable (n=25)</a:t>
                  </a: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55" name="テキスト ボックス 31"/>
                <p:cNvSpPr/>
                <p:nvPr/>
              </p:nvSpPr>
              <p:spPr>
                <a:xfrm>
                  <a:off x="855360" y="4467600"/>
                  <a:ext cx="3601080" cy="642600"/>
                </a:xfrm>
                <a:prstGeom prst="rect">
                  <a:avLst/>
                </a:prstGeom>
                <a:solidFill>
                  <a:srgbClr val="ffffff"/>
                </a:solidFill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2960"/>
                      <a:tab algn="l" pos="1825560"/>
                      <a:tab algn="l" pos="2738520"/>
                      <a:tab algn="l" pos="3651120"/>
                      <a:tab algn="l" pos="4564080"/>
                      <a:tab algn="l" pos="5477040"/>
                      <a:tab algn="l" pos="6389640"/>
                      <a:tab algn="l" pos="7302600"/>
                      <a:tab algn="l" pos="8215200"/>
                      <a:tab algn="l" pos="9128160"/>
                      <a:tab algn="l" pos="10040760"/>
                      <a:tab algn="l" pos="10953720"/>
                    </a:tabLst>
                  </a:pPr>
                  <a:r>
                    <a:rPr b="0" lang="en-US" sz="1800" spc="-1" strike="noStrike">
                      <a:solidFill>
                        <a:srgbClr val="000000"/>
                      </a:solidFill>
                      <a:latin typeface="Arial"/>
                      <a:ea typeface="游ゴシック"/>
                    </a:rPr>
                    <a:t>Excluded (n=6)</a:t>
                  </a: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2960"/>
                      <a:tab algn="l" pos="1825560"/>
                      <a:tab algn="l" pos="2738520"/>
                      <a:tab algn="l" pos="3651120"/>
                      <a:tab algn="l" pos="4564080"/>
                      <a:tab algn="l" pos="5477040"/>
                      <a:tab algn="l" pos="6389640"/>
                      <a:tab algn="l" pos="7302600"/>
                      <a:tab algn="l" pos="8215200"/>
                      <a:tab algn="l" pos="9128160"/>
                      <a:tab algn="l" pos="10040760"/>
                      <a:tab algn="l" pos="10953720"/>
                    </a:tabLst>
                  </a:pPr>
                  <a:r>
                    <a:rPr b="0" lang="ja-JP" sz="1800" spc="-1" strike="noStrike">
                      <a:solidFill>
                        <a:srgbClr val="000000"/>
                      </a:solidFill>
                      <a:latin typeface="Arial"/>
                      <a:ea typeface="游ゴシック"/>
                    </a:rPr>
                    <a:t>・</a:t>
                  </a:r>
                  <a:r>
                    <a:rPr b="0" lang="en-US" sz="1800" spc="-1" strike="noStrike">
                      <a:solidFill>
                        <a:srgbClr val="000000"/>
                      </a:solidFill>
                      <a:latin typeface="Arial"/>
                      <a:ea typeface="Segoe UI Symbol"/>
                    </a:rPr>
                    <a:t> </a:t>
                  </a:r>
                  <a:r>
                    <a:rPr b="0" lang="en-US" sz="1800" spc="-1" strike="noStrike">
                      <a:solidFill>
                        <a:srgbClr val="000000"/>
                      </a:solidFill>
                      <a:latin typeface="Arial"/>
                      <a:ea typeface="Segoe UI Symbol"/>
                    </a:rPr>
                    <a:t>Insufficient sample quality</a:t>
                  </a: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56" name="テキスト ボックス 32"/>
                <p:cNvSpPr/>
                <p:nvPr/>
              </p:nvSpPr>
              <p:spPr>
                <a:xfrm>
                  <a:off x="257040" y="5355000"/>
                  <a:ext cx="4166280" cy="642600"/>
                </a:xfrm>
                <a:prstGeom prst="rect">
                  <a:avLst/>
                </a:prstGeom>
                <a:gradFill rotWithShape="0">
                  <a:gsLst>
                    <a:gs pos="0">
                      <a:srgbClr val="d2d2d2"/>
                    </a:gs>
                    <a:gs pos="100000">
                      <a:srgbClr val="c0c0c0"/>
                    </a:gs>
                  </a:gsLst>
                  <a:lin ang="5400000"/>
                </a:gradFill>
                <a:ln w="6480">
                  <a:solidFill>
                    <a:srgbClr val="a5a5a5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2960"/>
                      <a:tab algn="l" pos="1825560"/>
                      <a:tab algn="l" pos="2738520"/>
                      <a:tab algn="l" pos="3651120"/>
                      <a:tab algn="l" pos="4564080"/>
                      <a:tab algn="l" pos="5477040"/>
                      <a:tab algn="l" pos="6389640"/>
                      <a:tab algn="l" pos="7302600"/>
                      <a:tab algn="l" pos="8215200"/>
                      <a:tab algn="l" pos="9128160"/>
                      <a:tab algn="l" pos="10040760"/>
                      <a:tab algn="l" pos="10953720"/>
                    </a:tabLst>
                  </a:pPr>
                  <a:r>
                    <a:rPr b="0" lang="en-US" sz="1800" spc="-1" strike="noStrike">
                      <a:solidFill>
                        <a:srgbClr val="000000"/>
                      </a:solidFill>
                      <a:latin typeface="Arial"/>
                      <a:ea typeface="游ゴシック"/>
                    </a:rPr>
                    <a:t>Vulvar squamous cell carcinoma (n=19)</a:t>
                  </a: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cxnSp>
              <p:nvCxnSpPr>
                <p:cNvPr id="57" name="直線矢印コネクタ 33"/>
                <p:cNvCxnSpPr/>
                <p:nvPr/>
              </p:nvCxnSpPr>
              <p:spPr>
                <a:xfrm>
                  <a:off x="347040" y="4765680"/>
                  <a:ext cx="508680" cy="1080"/>
                </a:xfrm>
                <a:prstGeom prst="straightConnector1">
                  <a:avLst/>
                </a:prstGeom>
                <a:ln w="19080">
                  <a:solidFill>
                    <a:srgbClr val="000000"/>
                  </a:solidFill>
                  <a:miter/>
                  <a:tailEnd len="med" type="triangle" w="med"/>
                </a:ln>
              </p:spPr>
            </p:cxnSp>
            <p:sp>
              <p:nvSpPr>
                <p:cNvPr id="58" name="テキスト ボックス 34"/>
                <p:cNvSpPr/>
                <p:nvPr/>
              </p:nvSpPr>
              <p:spPr>
                <a:xfrm>
                  <a:off x="288720" y="735480"/>
                  <a:ext cx="4156560" cy="642600"/>
                </a:xfrm>
                <a:prstGeom prst="rect">
                  <a:avLst/>
                </a:prstGeom>
                <a:solidFill>
                  <a:srgbClr val="ffffff"/>
                </a:solidFill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2960"/>
                      <a:tab algn="l" pos="1825560"/>
                      <a:tab algn="l" pos="2738520"/>
                      <a:tab algn="l" pos="3651120"/>
                      <a:tab algn="l" pos="4564080"/>
                      <a:tab algn="l" pos="5477040"/>
                      <a:tab algn="l" pos="6389640"/>
                      <a:tab algn="l" pos="7302600"/>
                      <a:tab algn="l" pos="8215200"/>
                      <a:tab algn="l" pos="9128160"/>
                      <a:tab algn="l" pos="10040760"/>
                      <a:tab algn="l" pos="10953720"/>
                    </a:tabLst>
                  </a:pPr>
                  <a:r>
                    <a:rPr b="0" lang="en-US" sz="1800" spc="-1" strike="noStrike">
                      <a:solidFill>
                        <a:srgbClr val="000000"/>
                      </a:solidFill>
                      <a:latin typeface="Arial"/>
                      <a:ea typeface="游ゴシック"/>
                    </a:rPr>
                    <a:t>Vulvar carcinoma patients treated at  NCCH (2015-2023) (n=42) </a:t>
                  </a: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</p:grpSp>
          <p:sp>
            <p:nvSpPr>
              <p:cNvPr id="59" name="テキスト ボックス 29"/>
              <p:cNvSpPr/>
              <p:nvPr/>
            </p:nvSpPr>
            <p:spPr>
              <a:xfrm>
                <a:off x="288720" y="358920"/>
                <a:ext cx="4219560" cy="642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2960"/>
                    <a:tab algn="l" pos="1825560"/>
                    <a:tab algn="l" pos="2738520"/>
                    <a:tab algn="l" pos="3651120"/>
                    <a:tab algn="l" pos="4564080"/>
                    <a:tab algn="l" pos="5477040"/>
                    <a:tab algn="l" pos="6389640"/>
                    <a:tab algn="l" pos="7302600"/>
                    <a:tab algn="l" pos="8215200"/>
                    <a:tab algn="l" pos="9128160"/>
                    <a:tab algn="l" pos="10040760"/>
                    <a:tab algn="l" pos="10953720"/>
                  </a:tabLst>
                </a:pPr>
                <a:r>
                  <a:rPr b="0" lang="en-US" sz="1800" spc="-1" strike="noStrike">
                    <a:solidFill>
                      <a:srgbClr val="000000"/>
                    </a:solidFill>
                    <a:latin typeface="Arial"/>
                    <a:ea typeface="游ゴシック"/>
                  </a:rPr>
                  <a:t>(A) NCCH cohort </a:t>
                </a: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  <a:p>
                <a:pPr algn="ctr">
                  <a:lnSpc>
                    <a:spcPct val="100000"/>
                  </a:lnSpc>
                  <a:tabLst>
                    <a:tab algn="l" pos="0"/>
                    <a:tab algn="l" pos="912960"/>
                    <a:tab algn="l" pos="1825560"/>
                    <a:tab algn="l" pos="2738520"/>
                    <a:tab algn="l" pos="3651120"/>
                    <a:tab algn="l" pos="4564080"/>
                    <a:tab algn="l" pos="5477040"/>
                    <a:tab algn="l" pos="6389640"/>
                    <a:tab algn="l" pos="7302600"/>
                    <a:tab algn="l" pos="8215200"/>
                    <a:tab algn="l" pos="9128160"/>
                    <a:tab algn="l" pos="10040760"/>
                    <a:tab algn="l" pos="1095372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grpSp>
          <p:nvGrpSpPr>
            <p:cNvPr id="60" name="グループ化 1"/>
            <p:cNvGrpSpPr/>
            <p:nvPr/>
          </p:nvGrpSpPr>
          <p:grpSpPr>
            <a:xfrm>
              <a:off x="4821120" y="358920"/>
              <a:ext cx="4218120" cy="5627880"/>
              <a:chOff x="4821120" y="358920"/>
              <a:chExt cx="4218120" cy="5627880"/>
            </a:xfrm>
          </p:grpSpPr>
          <p:sp>
            <p:nvSpPr>
              <p:cNvPr id="61" name="テキスト ボックス 27"/>
              <p:cNvSpPr/>
              <p:nvPr/>
            </p:nvSpPr>
            <p:spPr>
              <a:xfrm>
                <a:off x="4821120" y="358920"/>
                <a:ext cx="4218120" cy="642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2960"/>
                    <a:tab algn="l" pos="1825560"/>
                    <a:tab algn="l" pos="2738520"/>
                    <a:tab algn="l" pos="3651120"/>
                    <a:tab algn="l" pos="4564080"/>
                    <a:tab algn="l" pos="5477040"/>
                    <a:tab algn="l" pos="6389640"/>
                    <a:tab algn="l" pos="7302600"/>
                    <a:tab algn="l" pos="8215200"/>
                    <a:tab algn="l" pos="9128160"/>
                    <a:tab algn="l" pos="10040760"/>
                    <a:tab algn="l" pos="10953720"/>
                  </a:tabLst>
                </a:pPr>
                <a:r>
                  <a:rPr b="0" lang="en-US" sz="1800" spc="-1" strike="noStrike">
                    <a:solidFill>
                      <a:srgbClr val="000000"/>
                    </a:solidFill>
                    <a:latin typeface="Arial"/>
                    <a:ea typeface="游ゴシック"/>
                  </a:rPr>
                  <a:t>(B) C-CAT cohort </a:t>
                </a: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  <a:p>
                <a:pPr algn="ctr">
                  <a:lnSpc>
                    <a:spcPct val="100000"/>
                  </a:lnSpc>
                  <a:tabLst>
                    <a:tab algn="l" pos="0"/>
                    <a:tab algn="l" pos="912960"/>
                    <a:tab algn="l" pos="1825560"/>
                    <a:tab algn="l" pos="2738520"/>
                    <a:tab algn="l" pos="3651120"/>
                    <a:tab algn="l" pos="4564080"/>
                    <a:tab algn="l" pos="5477040"/>
                    <a:tab algn="l" pos="6389640"/>
                    <a:tab algn="l" pos="7302600"/>
                    <a:tab algn="l" pos="8215200"/>
                    <a:tab algn="l" pos="9128160"/>
                    <a:tab algn="l" pos="10040760"/>
                    <a:tab algn="l" pos="1095372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grpSp>
            <p:nvGrpSpPr>
              <p:cNvPr id="62" name="グループ化 5"/>
              <p:cNvGrpSpPr/>
              <p:nvPr/>
            </p:nvGrpSpPr>
            <p:grpSpPr>
              <a:xfrm>
                <a:off x="4828680" y="721440"/>
                <a:ext cx="4210560" cy="5265360"/>
                <a:chOff x="4828680" y="721440"/>
                <a:chExt cx="4210560" cy="5265360"/>
              </a:xfrm>
            </p:grpSpPr>
            <p:grpSp>
              <p:nvGrpSpPr>
                <p:cNvPr id="63" name="グループ化 3"/>
                <p:cNvGrpSpPr/>
                <p:nvPr/>
              </p:nvGrpSpPr>
              <p:grpSpPr>
                <a:xfrm>
                  <a:off x="4828680" y="721440"/>
                  <a:ext cx="4172040" cy="4632120"/>
                  <a:chOff x="4828680" y="721440"/>
                  <a:chExt cx="4172040" cy="4632120"/>
                </a:xfrm>
              </p:grpSpPr>
              <p:grpSp>
                <p:nvGrpSpPr>
                  <p:cNvPr id="64" name="グループ化 28"/>
                  <p:cNvGrpSpPr/>
                  <p:nvPr/>
                </p:nvGrpSpPr>
                <p:grpSpPr>
                  <a:xfrm>
                    <a:off x="4828680" y="721440"/>
                    <a:ext cx="4172040" cy="4632120"/>
                    <a:chOff x="4828680" y="721440"/>
                    <a:chExt cx="4172040" cy="4632120"/>
                  </a:xfrm>
                </p:grpSpPr>
                <p:cxnSp>
                  <p:nvCxnSpPr>
                    <p:cNvPr id="65" name="直線矢印コネクタ 15"/>
                    <p:cNvCxnSpPr/>
                    <p:nvPr/>
                  </p:nvCxnSpPr>
                  <p:spPr>
                    <a:xfrm>
                      <a:off x="4939560" y="1235160"/>
                      <a:ext cx="11520" cy="4118760"/>
                    </a:xfrm>
                    <a:prstGeom prst="straightConnector1">
                      <a:avLst/>
                    </a:prstGeom>
                    <a:ln w="19080">
                      <a:solidFill>
                        <a:srgbClr val="000000"/>
                      </a:solidFill>
                      <a:miter/>
                      <a:tailEnd len="med" type="triangle" w="med"/>
                    </a:ln>
                  </p:spPr>
                </p:cxnSp>
                <p:cxnSp>
                  <p:nvCxnSpPr>
                    <p:cNvPr id="66" name="直線矢印コネクタ 16"/>
                    <p:cNvCxnSpPr/>
                    <p:nvPr/>
                  </p:nvCxnSpPr>
                  <p:spPr>
                    <a:xfrm>
                      <a:off x="4949280" y="1879920"/>
                      <a:ext cx="460800" cy="1080"/>
                    </a:xfrm>
                    <a:prstGeom prst="straightConnector1">
                      <a:avLst/>
                    </a:prstGeom>
                    <a:ln w="19080">
                      <a:solidFill>
                        <a:srgbClr val="000000"/>
                      </a:solidFill>
                      <a:miter/>
                      <a:tailEnd len="med" type="triangle" w="med"/>
                    </a:ln>
                  </p:spPr>
                </p:cxnSp>
                <p:sp>
                  <p:nvSpPr>
                    <p:cNvPr id="67" name="テキスト ボックス 17"/>
                    <p:cNvSpPr/>
                    <p:nvPr/>
                  </p:nvSpPr>
                  <p:spPr>
                    <a:xfrm>
                      <a:off x="5419080" y="1575360"/>
                      <a:ext cx="3565800" cy="642600"/>
                    </a:xfrm>
                    <a:prstGeom prst="rect">
                      <a:avLst/>
                    </a:prstGeom>
                    <a:solidFill>
                      <a:srgbClr val="ffffff"/>
                    </a:solidFill>
                    <a:ln w="1260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t">
                      <a:spAutoFit/>
                    </a:bodyPr>
                    <a:p>
                      <a:pPr marL="114480" indent="-114480">
                        <a:lnSpc>
                          <a:spcPct val="100000"/>
                        </a:lnSpc>
                        <a:tabLst>
                          <a:tab algn="l" pos="0"/>
                          <a:tab algn="l" pos="912960"/>
                          <a:tab algn="l" pos="1825560"/>
                          <a:tab algn="l" pos="2738520"/>
                          <a:tab algn="l" pos="3651120"/>
                          <a:tab algn="l" pos="4564080"/>
                          <a:tab algn="l" pos="5477040"/>
                          <a:tab algn="l" pos="6389640"/>
                          <a:tab algn="l" pos="7302600"/>
                          <a:tab algn="l" pos="8215200"/>
                          <a:tab algn="l" pos="9128160"/>
                          <a:tab algn="l" pos="10040760"/>
                          <a:tab algn="l" pos="10953720"/>
                        </a:tabLst>
                      </a:pPr>
                      <a:r>
                        <a:rPr b="0" lang="en-US" sz="1800" spc="-1" strike="noStrike">
                          <a:solidFill>
                            <a:srgbClr val="000000"/>
                          </a:solidFill>
                          <a:latin typeface="Arial"/>
                          <a:ea typeface="游ゴシック"/>
                        </a:rPr>
                        <a:t>Excluded (n=30)</a:t>
                      </a: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  <a:p>
                      <a:pPr marL="114480" indent="-114480">
                        <a:lnSpc>
                          <a:spcPct val="100000"/>
                        </a:lnSpc>
                        <a:tabLst>
                          <a:tab algn="l" pos="0"/>
                          <a:tab algn="l" pos="912960"/>
                          <a:tab algn="l" pos="1825560"/>
                          <a:tab algn="l" pos="2738520"/>
                          <a:tab algn="l" pos="3651120"/>
                          <a:tab algn="l" pos="4564080"/>
                          <a:tab algn="l" pos="5477040"/>
                          <a:tab algn="l" pos="6389640"/>
                          <a:tab algn="l" pos="7302600"/>
                          <a:tab algn="l" pos="8215200"/>
                          <a:tab algn="l" pos="9128160"/>
                          <a:tab algn="l" pos="10040760"/>
                          <a:tab algn="l" pos="10953720"/>
                        </a:tabLst>
                      </a:pPr>
                      <a:r>
                        <a:rPr b="0" lang="ja-JP" sz="1800" spc="-1" strike="noStrike">
                          <a:solidFill>
                            <a:srgbClr val="000000"/>
                          </a:solidFill>
                          <a:latin typeface="Arial"/>
                          <a:ea typeface="游ゴシック"/>
                        </a:rPr>
                        <a:t>・</a:t>
                      </a:r>
                      <a:r>
                        <a:rPr b="0" lang="en" sz="1800" spc="-1" strike="noStrike">
                          <a:solidFill>
                            <a:srgbClr val="000000"/>
                          </a:solidFill>
                          <a:latin typeface="Arial"/>
                          <a:ea typeface="游ゴシック"/>
                        </a:rPr>
                        <a:t> </a:t>
                      </a:r>
                      <a:r>
                        <a:rPr b="0" lang="en-US" sz="1800" spc="-1" strike="noStrike">
                          <a:solidFill>
                            <a:srgbClr val="000000"/>
                          </a:solidFill>
                          <a:latin typeface="Arial"/>
                          <a:ea typeface="游ゴシック"/>
                        </a:rPr>
                        <a:t>Vaginal cancer</a:t>
                      </a: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p:txBody>
                </p:sp>
                <p:sp>
                  <p:nvSpPr>
                    <p:cNvPr id="68" name="テキスト ボックス 18"/>
                    <p:cNvSpPr/>
                    <p:nvPr/>
                  </p:nvSpPr>
                  <p:spPr>
                    <a:xfrm>
                      <a:off x="4828680" y="2427840"/>
                      <a:ext cx="4156200" cy="368280"/>
                    </a:xfrm>
                    <a:prstGeom prst="rect">
                      <a:avLst/>
                    </a:prstGeom>
                    <a:solidFill>
                      <a:srgbClr val="ffffff"/>
                    </a:solidFill>
                    <a:ln w="1260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t">
                      <a:sp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2960"/>
                          <a:tab algn="l" pos="1825560"/>
                          <a:tab algn="l" pos="2738520"/>
                          <a:tab algn="l" pos="3651120"/>
                          <a:tab algn="l" pos="4564080"/>
                          <a:tab algn="l" pos="5477040"/>
                          <a:tab algn="l" pos="6389640"/>
                          <a:tab algn="l" pos="7302600"/>
                          <a:tab algn="l" pos="8215200"/>
                          <a:tab algn="l" pos="9128160"/>
                          <a:tab algn="l" pos="10040760"/>
                          <a:tab algn="l" pos="10953720"/>
                        </a:tabLst>
                      </a:pPr>
                      <a:r>
                        <a:rPr b="0" lang="en-US" sz="1800" spc="-1" strike="noStrike">
                          <a:solidFill>
                            <a:srgbClr val="000000"/>
                          </a:solidFill>
                          <a:latin typeface="Arial"/>
                          <a:ea typeface="游ゴシック"/>
                        </a:rPr>
                        <a:t>Vulvar cancer (n=61)</a:t>
                      </a: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p:txBody>
                </p:sp>
                <p:sp>
                  <p:nvSpPr>
                    <p:cNvPr id="69" name="テキスト ボックス 19"/>
                    <p:cNvSpPr/>
                    <p:nvPr/>
                  </p:nvSpPr>
                  <p:spPr>
                    <a:xfrm>
                      <a:off x="5398560" y="2999520"/>
                      <a:ext cx="3602160" cy="2071800"/>
                    </a:xfrm>
                    <a:prstGeom prst="rect">
                      <a:avLst/>
                    </a:prstGeom>
                    <a:solidFill>
                      <a:srgbClr val="ffffff"/>
                    </a:solidFill>
                    <a:ln w="1260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t">
                      <a:sp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2960"/>
                          <a:tab algn="l" pos="1825560"/>
                          <a:tab algn="l" pos="2738520"/>
                          <a:tab algn="l" pos="3651120"/>
                          <a:tab algn="l" pos="4564080"/>
                          <a:tab algn="l" pos="5477040"/>
                          <a:tab algn="l" pos="6389640"/>
                          <a:tab algn="l" pos="7302600"/>
                          <a:tab algn="l" pos="8215200"/>
                          <a:tab algn="l" pos="9128160"/>
                          <a:tab algn="l" pos="10040760"/>
                          <a:tab algn="l" pos="10953720"/>
                        </a:tabLst>
                      </a:pPr>
                      <a:r>
                        <a:rPr b="0" lang="en-US" sz="1800" spc="-1" strike="noStrike">
                          <a:solidFill>
                            <a:srgbClr val="000000"/>
                          </a:solidFill>
                          <a:latin typeface="Arial"/>
                          <a:ea typeface="游ゴシック"/>
                        </a:rPr>
                        <a:t>Excluded (n=32)</a:t>
                      </a: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2960"/>
                          <a:tab algn="l" pos="1825560"/>
                          <a:tab algn="l" pos="2738520"/>
                          <a:tab algn="l" pos="3651120"/>
                          <a:tab algn="l" pos="4564080"/>
                          <a:tab algn="l" pos="5477040"/>
                          <a:tab algn="l" pos="6389640"/>
                          <a:tab algn="l" pos="7302600"/>
                          <a:tab algn="l" pos="8215200"/>
                          <a:tab algn="l" pos="9128160"/>
                          <a:tab algn="l" pos="10040760"/>
                          <a:tab algn="l" pos="10953720"/>
                        </a:tabLst>
                      </a:pPr>
                      <a:r>
                        <a:rPr b="0" lang="ja-JP" sz="1600" spc="-1" strike="noStrike">
                          <a:solidFill>
                            <a:srgbClr val="000000"/>
                          </a:solidFill>
                          <a:latin typeface="Arial"/>
                          <a:ea typeface="游ゴシック"/>
                        </a:rPr>
                        <a:t>・</a:t>
                      </a:r>
                      <a:r>
                        <a:rPr b="0" lang="en" sz="1600" spc="-1" strike="noStrike">
                          <a:solidFill>
                            <a:srgbClr val="000000"/>
                          </a:solidFill>
                          <a:latin typeface="Arial"/>
                          <a:ea typeface="游ゴシック"/>
                        </a:rPr>
                        <a:t>Panel test performed blood-derived </a:t>
                      </a: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Arial"/>
                          <a:ea typeface="游ゴシック"/>
                        </a:rPr>
                        <a:t>(n=1) 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2960"/>
                          <a:tab algn="l" pos="1825560"/>
                          <a:tab algn="l" pos="2738520"/>
                          <a:tab algn="l" pos="3651120"/>
                          <a:tab algn="l" pos="4564080"/>
                          <a:tab algn="l" pos="5477040"/>
                          <a:tab algn="l" pos="6389640"/>
                          <a:tab algn="l" pos="7302600"/>
                          <a:tab algn="l" pos="8215200"/>
                          <a:tab algn="l" pos="9128160"/>
                          <a:tab algn="l" pos="10040760"/>
                          <a:tab algn="l" pos="10953720"/>
                        </a:tabLst>
                      </a:pPr>
                      <a:r>
                        <a:rPr b="0" lang="ja-JP" sz="1600" spc="-1" strike="noStrike">
                          <a:solidFill>
                            <a:srgbClr val="000000"/>
                          </a:solidFill>
                          <a:latin typeface="Arial"/>
                          <a:ea typeface="游ゴシック"/>
                        </a:rPr>
                        <a:t>・</a:t>
                      </a: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Arial"/>
                          <a:ea typeface="游ゴシック"/>
                        </a:rPr>
                        <a:t>Other histological types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2960"/>
                          <a:tab algn="l" pos="1825560"/>
                          <a:tab algn="l" pos="2738520"/>
                          <a:tab algn="l" pos="3651120"/>
                          <a:tab algn="l" pos="4564080"/>
                          <a:tab algn="l" pos="5477040"/>
                          <a:tab algn="l" pos="6389640"/>
                          <a:tab algn="l" pos="7302600"/>
                          <a:tab algn="l" pos="8215200"/>
                          <a:tab algn="l" pos="9128160"/>
                          <a:tab algn="l" pos="10040760"/>
                          <a:tab algn="l" pos="10953720"/>
                        </a:tabLst>
                      </a:pPr>
                      <a:r>
                        <a:rPr b="0" lang="ja-JP" sz="1600" spc="-1" strike="noStrike">
                          <a:solidFill>
                            <a:srgbClr val="000000"/>
                          </a:solidFill>
                          <a:latin typeface="Arial"/>
                          <a:ea typeface="游ゴシック"/>
                        </a:rPr>
                        <a:t>　</a:t>
                      </a: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Arial"/>
                          <a:ea typeface="游ゴシック"/>
                        </a:rPr>
                        <a:t>Adenocarcinoma (n=8)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2960"/>
                          <a:tab algn="l" pos="1825560"/>
                          <a:tab algn="l" pos="2738520"/>
                          <a:tab algn="l" pos="3651120"/>
                          <a:tab algn="l" pos="4564080"/>
                          <a:tab algn="l" pos="5477040"/>
                          <a:tab algn="l" pos="6389640"/>
                          <a:tab algn="l" pos="7302600"/>
                          <a:tab algn="l" pos="8215200"/>
                          <a:tab algn="l" pos="9128160"/>
                          <a:tab algn="l" pos="10040760"/>
                          <a:tab algn="l" pos="10953720"/>
                        </a:tabLst>
                      </a:pPr>
                      <a:r>
                        <a:rPr b="0" lang="ja-JP" sz="1600" spc="-1" strike="noStrike">
                          <a:solidFill>
                            <a:srgbClr val="000000"/>
                          </a:solidFill>
                          <a:latin typeface="Arial"/>
                          <a:ea typeface="游ゴシック"/>
                        </a:rPr>
                        <a:t>　</a:t>
                      </a: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Arial"/>
                          <a:ea typeface="游ゴシック"/>
                        </a:rPr>
                        <a:t>Melanoma (n=16)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2960"/>
                          <a:tab algn="l" pos="1825560"/>
                          <a:tab algn="l" pos="2738520"/>
                          <a:tab algn="l" pos="3651120"/>
                          <a:tab algn="l" pos="4564080"/>
                          <a:tab algn="l" pos="5477040"/>
                          <a:tab algn="l" pos="6389640"/>
                          <a:tab algn="l" pos="7302600"/>
                          <a:tab algn="l" pos="8215200"/>
                          <a:tab algn="l" pos="9128160"/>
                          <a:tab algn="l" pos="10040760"/>
                          <a:tab algn="l" pos="10953720"/>
                        </a:tabLst>
                      </a:pPr>
                      <a:r>
                        <a:rPr b="0" lang="ja-JP" sz="1600" spc="-1" strike="noStrike">
                          <a:solidFill>
                            <a:srgbClr val="000000"/>
                          </a:solidFill>
                          <a:latin typeface="Arial"/>
                          <a:ea typeface="游ゴシック"/>
                        </a:rPr>
                        <a:t>　</a:t>
                      </a: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Arial"/>
                          <a:ea typeface="游ゴシック"/>
                        </a:rPr>
                        <a:t>Miscellaneous (n=4)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2960"/>
                          <a:tab algn="l" pos="1825560"/>
                          <a:tab algn="l" pos="2738520"/>
                          <a:tab algn="l" pos="3651120"/>
                          <a:tab algn="l" pos="4564080"/>
                          <a:tab algn="l" pos="5477040"/>
                          <a:tab algn="l" pos="6389640"/>
                          <a:tab algn="l" pos="7302600"/>
                          <a:tab algn="l" pos="8215200"/>
                          <a:tab algn="l" pos="9128160"/>
                          <a:tab algn="l" pos="10040760"/>
                          <a:tab algn="l" pos="10953720"/>
                        </a:tabLst>
                      </a:pPr>
                      <a:r>
                        <a:rPr b="0" lang="ja-JP" sz="1600" spc="-1" strike="noStrike">
                          <a:solidFill>
                            <a:srgbClr val="000000"/>
                          </a:solidFill>
                          <a:latin typeface="Arial"/>
                          <a:ea typeface="游ゴシック"/>
                        </a:rPr>
                        <a:t>　</a:t>
                      </a: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Arial"/>
                          <a:ea typeface="游ゴシック"/>
                        </a:rPr>
                        <a:t>Unknown (n=3)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p:txBody>
                </p:sp>
                <p:sp>
                  <p:nvSpPr>
                    <p:cNvPr id="70" name="テキスト ボックス 22"/>
                    <p:cNvSpPr/>
                    <p:nvPr/>
                  </p:nvSpPr>
                  <p:spPr>
                    <a:xfrm>
                      <a:off x="4831560" y="721440"/>
                      <a:ext cx="4156200" cy="824040"/>
                    </a:xfrm>
                    <a:prstGeom prst="rect">
                      <a:avLst/>
                    </a:prstGeom>
                    <a:solidFill>
                      <a:srgbClr val="ffffff"/>
                    </a:solidFill>
                    <a:ln w="1260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t">
                      <a:sp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2960"/>
                          <a:tab algn="l" pos="1825560"/>
                          <a:tab algn="l" pos="2738520"/>
                          <a:tab algn="l" pos="3651120"/>
                          <a:tab algn="l" pos="4564080"/>
                          <a:tab algn="l" pos="5477040"/>
                          <a:tab algn="l" pos="6389640"/>
                          <a:tab algn="l" pos="7302600"/>
                          <a:tab algn="l" pos="8215200"/>
                          <a:tab algn="l" pos="9128160"/>
                          <a:tab algn="l" pos="10040760"/>
                          <a:tab algn="l" pos="1095372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Arial"/>
                          <a:ea typeface="游ゴシック"/>
                        </a:rPr>
                        <a:t>C-CAT</a:t>
                      </a:r>
                      <a:r>
                        <a:rPr b="0" lang="ja-JP" sz="1600" spc="-1" strike="noStrike">
                          <a:solidFill>
                            <a:srgbClr val="000000"/>
                          </a:solidFill>
                          <a:latin typeface="Arial"/>
                          <a:ea typeface="游ゴシック"/>
                        </a:rPr>
                        <a:t> </a:t>
                      </a: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Arial"/>
                          <a:ea typeface="游ゴシック"/>
                        </a:rPr>
                        <a:t>(ver. 20221218) dataset (2019-2022)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2960"/>
                          <a:tab algn="l" pos="1825560"/>
                          <a:tab algn="l" pos="2738520"/>
                          <a:tab algn="l" pos="3651120"/>
                          <a:tab algn="l" pos="4564080"/>
                          <a:tab algn="l" pos="5477040"/>
                          <a:tab algn="l" pos="6389640"/>
                          <a:tab algn="l" pos="7302600"/>
                          <a:tab algn="l" pos="8215200"/>
                          <a:tab algn="l" pos="9128160"/>
                          <a:tab algn="l" pos="10040760"/>
                          <a:tab algn="l" pos="1095372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Arial"/>
                          <a:ea typeface="游ゴシック"/>
                        </a:rPr>
                        <a:t> </a:t>
                      </a: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Arial"/>
                          <a:ea typeface="游ゴシック"/>
                        </a:rPr>
                        <a:t>Vulvar/ vaginal Cancer (n=91)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p:txBody>
                </p:sp>
              </p:grpSp>
              <p:cxnSp>
                <p:nvCxnSpPr>
                  <p:cNvPr id="71" name="直線矢印コネクタ 35"/>
                  <p:cNvCxnSpPr/>
                  <p:nvPr/>
                </p:nvCxnSpPr>
                <p:spPr>
                  <a:xfrm>
                    <a:off x="4942800" y="4089600"/>
                    <a:ext cx="461160" cy="1080"/>
                  </a:xfrm>
                  <a:prstGeom prst="straightConnector1">
                    <a:avLst/>
                  </a:prstGeom>
                  <a:ln w="19080">
                    <a:solidFill>
                      <a:srgbClr val="000000"/>
                    </a:solidFill>
                    <a:miter/>
                    <a:tailEnd len="med" type="triangle" w="med"/>
                  </a:ln>
                </p:spPr>
              </p:cxnSp>
            </p:grpSp>
            <p:sp>
              <p:nvSpPr>
                <p:cNvPr id="72" name="テキスト ボックス 36"/>
                <p:cNvSpPr/>
                <p:nvPr/>
              </p:nvSpPr>
              <p:spPr>
                <a:xfrm>
                  <a:off x="4874760" y="5344200"/>
                  <a:ext cx="4164480" cy="642600"/>
                </a:xfrm>
                <a:prstGeom prst="rect">
                  <a:avLst/>
                </a:prstGeom>
                <a:gradFill rotWithShape="0">
                  <a:gsLst>
                    <a:gs pos="0">
                      <a:srgbClr val="d2d2d2"/>
                    </a:gs>
                    <a:gs pos="100000">
                      <a:srgbClr val="c0c0c0"/>
                    </a:gs>
                  </a:gsLst>
                  <a:lin ang="5400000"/>
                </a:gradFill>
                <a:ln w="6480">
                  <a:solidFill>
                    <a:srgbClr val="a5a5a5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2960"/>
                      <a:tab algn="l" pos="1825560"/>
                      <a:tab algn="l" pos="2738520"/>
                      <a:tab algn="l" pos="3651120"/>
                      <a:tab algn="l" pos="4564080"/>
                      <a:tab algn="l" pos="5477040"/>
                      <a:tab algn="l" pos="6389640"/>
                      <a:tab algn="l" pos="7302600"/>
                      <a:tab algn="l" pos="8215200"/>
                      <a:tab algn="l" pos="9128160"/>
                      <a:tab algn="l" pos="10040760"/>
                      <a:tab algn="l" pos="10953720"/>
                    </a:tabLst>
                  </a:pPr>
                  <a:r>
                    <a:rPr b="0" lang="en-US" sz="1800" spc="-1" strike="noStrike">
                      <a:solidFill>
                        <a:srgbClr val="000000"/>
                      </a:solidFill>
                      <a:latin typeface="Arial"/>
                      <a:ea typeface="游ゴシック"/>
                    </a:rPr>
                    <a:t>Vulvar squamous cell carcinoma (n=29)</a:t>
                  </a: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</p:grpSp>
        </p:grpSp>
      </p:grpSp>
      <p:sp>
        <p:nvSpPr>
          <p:cNvPr id="73" name="テキスト ボックス 2"/>
          <p:cNvSpPr/>
          <p:nvPr/>
        </p:nvSpPr>
        <p:spPr>
          <a:xfrm>
            <a:off x="8034480" y="6210360"/>
            <a:ext cx="100476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Arial"/>
                <a:ea typeface="游ゴシック"/>
              </a:rPr>
              <a:t>Fig. S1</a:t>
            </a: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23-08-13T00:12:30Z</dcterms:created>
  <dc:creator>白石　航也</dc:creator>
  <dc:description/>
  <dc:language>en-US</dc:language>
  <cp:lastModifiedBy>白石　航也</cp:lastModifiedBy>
  <dcterms:modified xsi:type="dcterms:W3CDTF">2024-04-28T07:03:53Z</dcterms:modified>
  <cp:revision>18</cp:revision>
  <dc:subject/>
  <dc:title>PowerPoint プレゼンテーション</dc:title>
</cp:coreProperties>
</file>